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4.xml" ContentType="application/vnd.ms-office.chartstyle+xml"/>
  <Override PartName="/ppt/charts/colors4.xml" ContentType="application/vnd.ms-office.chartcolorstyle+xml"/>
  <Override PartName="/ppt/charts/style5.xml" ContentType="application/vnd.ms-office.chartstyle+xml"/>
  <Override PartName="/ppt/charts/colors5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1" autoAdjust="0"/>
    <p:restoredTop sz="94660"/>
  </p:normalViewPr>
  <p:slideViewPr>
    <p:cSldViewPr snapToGrid="0">
      <p:cViewPr>
        <p:scale>
          <a:sx n="73" d="100"/>
          <a:sy n="73" d="100"/>
        </p:scale>
        <p:origin x="-2246" y="797"/>
      </p:cViewPr>
      <p:guideLst>
        <p:guide orient="horz" pos="3093"/>
        <p:guide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4.xml"/><Relationship Id="rId2" Type="http://schemas.microsoft.com/office/2011/relationships/chartColorStyle" Target="colors4.xml"/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5.xml"/><Relationship Id="rId2" Type="http://schemas.microsoft.com/office/2011/relationships/chartColorStyle" Target="colors5.xml"/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7176190777761357E-2"/>
          <c:y val="8.1691948617694049E-2"/>
          <c:w val="0.90707760725619757"/>
          <c:h val="0.8251792299581347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Number of Cases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Tabelle1!$A$2:$A$11</c:f>
              <c:strCache>
                <c:ptCount val="10"/>
                <c:pt idx="0">
                  <c:v>0-2 </c:v>
                </c:pt>
                <c:pt idx="1">
                  <c:v>2-4 </c:v>
                </c:pt>
                <c:pt idx="2">
                  <c:v>4-6 </c:v>
                </c:pt>
                <c:pt idx="3">
                  <c:v>6-8 </c:v>
                </c:pt>
                <c:pt idx="4">
                  <c:v>8-10 </c:v>
                </c:pt>
                <c:pt idx="5">
                  <c:v>10-12 </c:v>
                </c:pt>
                <c:pt idx="6">
                  <c:v>12-14 </c:v>
                </c:pt>
                <c:pt idx="7">
                  <c:v>14-16 </c:v>
                </c:pt>
                <c:pt idx="8">
                  <c:v>16-18 </c:v>
                </c:pt>
                <c:pt idx="9">
                  <c:v>18-20 </c:v>
                </c:pt>
              </c:strCache>
            </c:strRef>
          </c:cat>
          <c:val>
            <c:numRef>
              <c:f>Tabelle1!$B$2:$B$11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2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209-4A1A-A004-9291119C850B}"/>
            </c:ext>
          </c:extLst>
        </c:ser>
        <c:ser>
          <c:idx val="1"/>
          <c:order val="1"/>
          <c:tx>
            <c:strRef>
              <c:f>Tabelle1!$C$1</c:f>
              <c:strCache>
                <c:ptCount val="1"/>
                <c:pt idx="0">
                  <c:v>Datenreihe 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Tabelle1!$A$2:$A$11</c:f>
              <c:strCache>
                <c:ptCount val="10"/>
                <c:pt idx="0">
                  <c:v>0-2 </c:v>
                </c:pt>
                <c:pt idx="1">
                  <c:v>2-4 </c:v>
                </c:pt>
                <c:pt idx="2">
                  <c:v>4-6 </c:v>
                </c:pt>
                <c:pt idx="3">
                  <c:v>6-8 </c:v>
                </c:pt>
                <c:pt idx="4">
                  <c:v>8-10 </c:v>
                </c:pt>
                <c:pt idx="5">
                  <c:v>10-12 </c:v>
                </c:pt>
                <c:pt idx="6">
                  <c:v>12-14 </c:v>
                </c:pt>
                <c:pt idx="7">
                  <c:v>14-16 </c:v>
                </c:pt>
                <c:pt idx="8">
                  <c:v>16-18 </c:v>
                </c:pt>
                <c:pt idx="9">
                  <c:v>18-20 </c:v>
                </c:pt>
              </c:strCache>
            </c:strRef>
          </c:cat>
          <c:val>
            <c:numRef>
              <c:f>Tabelle1!$C$2:$C$11</c:f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209-4A1A-A004-9291119C850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33717376"/>
        <c:axId val="133719168"/>
      </c:barChart>
      <c:lineChart>
        <c:grouping val="standard"/>
        <c:varyColors val="0"/>
        <c:ser>
          <c:idx val="2"/>
          <c:order val="2"/>
          <c:tx>
            <c:strRef>
              <c:f>Tabelle1!$D$1</c:f>
              <c:strCache>
                <c:ptCount val="1"/>
                <c:pt idx="0">
                  <c:v>Line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strRef>
              <c:f>Tabelle1!$A$2:$A$11</c:f>
              <c:strCache>
                <c:ptCount val="10"/>
                <c:pt idx="0">
                  <c:v>0-2 </c:v>
                </c:pt>
                <c:pt idx="1">
                  <c:v>2-4 </c:v>
                </c:pt>
                <c:pt idx="2">
                  <c:v>4-6 </c:v>
                </c:pt>
                <c:pt idx="3">
                  <c:v>6-8 </c:v>
                </c:pt>
                <c:pt idx="4">
                  <c:v>8-10 </c:v>
                </c:pt>
                <c:pt idx="5">
                  <c:v>10-12 </c:v>
                </c:pt>
                <c:pt idx="6">
                  <c:v>12-14 </c:v>
                </c:pt>
                <c:pt idx="7">
                  <c:v>14-16 </c:v>
                </c:pt>
                <c:pt idx="8">
                  <c:v>16-18 </c:v>
                </c:pt>
                <c:pt idx="9">
                  <c:v>18-20 </c:v>
                </c:pt>
              </c:strCache>
            </c:strRef>
          </c:cat>
          <c:val>
            <c:numRef>
              <c:f>Tabelle1!$D$2:$D$11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2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C209-4A1A-A004-9291119C850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3717376"/>
        <c:axId val="133719168"/>
      </c:lineChart>
      <c:catAx>
        <c:axId val="1337173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33719168"/>
        <c:crosses val="autoZero"/>
        <c:auto val="1"/>
        <c:lblAlgn val="ctr"/>
        <c:lblOffset val="100"/>
        <c:noMultiLvlLbl val="0"/>
      </c:catAx>
      <c:valAx>
        <c:axId val="13371916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33717376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1025988604580004E-2"/>
          <c:y val="6.1056196242764128E-2"/>
          <c:w val="0.88858462949331385"/>
          <c:h val="0.8194543611179970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Number of Cases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Tabelle1!$A$2:$A$11</c:f>
              <c:strCache>
                <c:ptCount val="10"/>
                <c:pt idx="0">
                  <c:v>0-2 </c:v>
                </c:pt>
                <c:pt idx="1">
                  <c:v>2-4</c:v>
                </c:pt>
                <c:pt idx="2">
                  <c:v>4-6 </c:v>
                </c:pt>
                <c:pt idx="3">
                  <c:v>6-8 </c:v>
                </c:pt>
                <c:pt idx="4">
                  <c:v>8-10 </c:v>
                </c:pt>
                <c:pt idx="5">
                  <c:v>10-12 </c:v>
                </c:pt>
                <c:pt idx="6">
                  <c:v>12-14 </c:v>
                </c:pt>
                <c:pt idx="7">
                  <c:v>14-16 </c:v>
                </c:pt>
                <c:pt idx="8">
                  <c:v>16-18 </c:v>
                </c:pt>
                <c:pt idx="9">
                  <c:v>18-20</c:v>
                </c:pt>
              </c:strCache>
            </c:strRef>
          </c:cat>
          <c:val>
            <c:numRef>
              <c:f>Tabelle1!$B$2:$B$11</c:f>
              <c:numCache>
                <c:formatCode>General</c:formatCode>
                <c:ptCount val="10"/>
                <c:pt idx="0">
                  <c:v>35</c:v>
                </c:pt>
                <c:pt idx="1">
                  <c:v>42</c:v>
                </c:pt>
                <c:pt idx="2">
                  <c:v>24</c:v>
                </c:pt>
                <c:pt idx="3">
                  <c:v>8</c:v>
                </c:pt>
                <c:pt idx="4">
                  <c:v>6</c:v>
                </c:pt>
                <c:pt idx="5">
                  <c:v>4</c:v>
                </c:pt>
                <c:pt idx="6">
                  <c:v>9</c:v>
                </c:pt>
                <c:pt idx="7">
                  <c:v>2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004-46CA-AF34-D7EB4F2E316D}"/>
            </c:ext>
          </c:extLst>
        </c:ser>
        <c:ser>
          <c:idx val="1"/>
          <c:order val="1"/>
          <c:tx>
            <c:strRef>
              <c:f>Tabelle1!$C$1</c:f>
              <c:strCache>
                <c:ptCount val="1"/>
                <c:pt idx="0">
                  <c:v>Datenreihe 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Tabelle1!$A$2:$A$11</c:f>
              <c:strCache>
                <c:ptCount val="10"/>
                <c:pt idx="0">
                  <c:v>0-2 </c:v>
                </c:pt>
                <c:pt idx="1">
                  <c:v>2-4</c:v>
                </c:pt>
                <c:pt idx="2">
                  <c:v>4-6 </c:v>
                </c:pt>
                <c:pt idx="3">
                  <c:v>6-8 </c:v>
                </c:pt>
                <c:pt idx="4">
                  <c:v>8-10 </c:v>
                </c:pt>
                <c:pt idx="5">
                  <c:v>10-12 </c:v>
                </c:pt>
                <c:pt idx="6">
                  <c:v>12-14 </c:v>
                </c:pt>
                <c:pt idx="7">
                  <c:v>14-16 </c:v>
                </c:pt>
                <c:pt idx="8">
                  <c:v>16-18 </c:v>
                </c:pt>
                <c:pt idx="9">
                  <c:v>18-20</c:v>
                </c:pt>
              </c:strCache>
            </c:strRef>
          </c:cat>
          <c:val>
            <c:numRef>
              <c:f>Tabelle1!$C$2:$C$11</c:f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5004-46CA-AF34-D7EB4F2E31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33930368"/>
        <c:axId val="133932160"/>
      </c:barChart>
      <c:lineChart>
        <c:grouping val="standard"/>
        <c:varyColors val="0"/>
        <c:ser>
          <c:idx val="2"/>
          <c:order val="2"/>
          <c:tx>
            <c:strRef>
              <c:f>Tabelle1!$D$1</c:f>
              <c:strCache>
                <c:ptCount val="1"/>
                <c:pt idx="0">
                  <c:v>Line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strRef>
              <c:f>Tabelle1!$A$2:$A$11</c:f>
              <c:strCache>
                <c:ptCount val="10"/>
                <c:pt idx="0">
                  <c:v>0-2 </c:v>
                </c:pt>
                <c:pt idx="1">
                  <c:v>2-4</c:v>
                </c:pt>
                <c:pt idx="2">
                  <c:v>4-6 </c:v>
                </c:pt>
                <c:pt idx="3">
                  <c:v>6-8 </c:v>
                </c:pt>
                <c:pt idx="4">
                  <c:v>8-10 </c:v>
                </c:pt>
                <c:pt idx="5">
                  <c:v>10-12 </c:v>
                </c:pt>
                <c:pt idx="6">
                  <c:v>12-14 </c:v>
                </c:pt>
                <c:pt idx="7">
                  <c:v>14-16 </c:v>
                </c:pt>
                <c:pt idx="8">
                  <c:v>16-18 </c:v>
                </c:pt>
                <c:pt idx="9">
                  <c:v>18-20</c:v>
                </c:pt>
              </c:strCache>
            </c:strRef>
          </c:cat>
          <c:val>
            <c:numRef>
              <c:f>Tabelle1!$D$2:$D$11</c:f>
              <c:numCache>
                <c:formatCode>General</c:formatCode>
                <c:ptCount val="10"/>
                <c:pt idx="0">
                  <c:v>35</c:v>
                </c:pt>
                <c:pt idx="1">
                  <c:v>42</c:v>
                </c:pt>
                <c:pt idx="2">
                  <c:v>24</c:v>
                </c:pt>
                <c:pt idx="3">
                  <c:v>8</c:v>
                </c:pt>
                <c:pt idx="4">
                  <c:v>6</c:v>
                </c:pt>
                <c:pt idx="5">
                  <c:v>4</c:v>
                </c:pt>
                <c:pt idx="6">
                  <c:v>9</c:v>
                </c:pt>
                <c:pt idx="7">
                  <c:v>2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5004-46CA-AF34-D7EB4F2E31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3930368"/>
        <c:axId val="133932160"/>
      </c:lineChart>
      <c:catAx>
        <c:axId val="1339303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33932160"/>
        <c:crosses val="autoZero"/>
        <c:auto val="1"/>
        <c:lblAlgn val="ctr"/>
        <c:lblOffset val="100"/>
        <c:noMultiLvlLbl val="0"/>
      </c:catAx>
      <c:valAx>
        <c:axId val="133932160"/>
        <c:scaling>
          <c:orientation val="minMax"/>
          <c:max val="5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33930368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B813F-7536-4757-AA28-A5B88A002BFA}" type="datetimeFigureOut">
              <a:rPr lang="de-DE" smtClean="0"/>
              <a:t>01.06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E8AFF-808F-4CF6-8FC9-21B079F571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5307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B813F-7536-4757-AA28-A5B88A002BFA}" type="datetimeFigureOut">
              <a:rPr lang="de-DE" smtClean="0"/>
              <a:t>01.06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E8AFF-808F-4CF6-8FC9-21B079F571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1022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B813F-7536-4757-AA28-A5B88A002BFA}" type="datetimeFigureOut">
              <a:rPr lang="de-DE" smtClean="0"/>
              <a:t>01.06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E8AFF-808F-4CF6-8FC9-21B079F571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8058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B813F-7536-4757-AA28-A5B88A002BFA}" type="datetimeFigureOut">
              <a:rPr lang="de-DE" smtClean="0"/>
              <a:t>01.06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E8AFF-808F-4CF6-8FC9-21B079F571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0222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B813F-7536-4757-AA28-A5B88A002BFA}" type="datetimeFigureOut">
              <a:rPr lang="de-DE" smtClean="0"/>
              <a:t>01.06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E8AFF-808F-4CF6-8FC9-21B079F571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23459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B813F-7536-4757-AA28-A5B88A002BFA}" type="datetimeFigureOut">
              <a:rPr lang="de-DE" smtClean="0"/>
              <a:t>01.06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E8AFF-808F-4CF6-8FC9-21B079F571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531678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B813F-7536-4757-AA28-A5B88A002BFA}" type="datetimeFigureOut">
              <a:rPr lang="de-DE" smtClean="0"/>
              <a:t>01.06.2019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E8AFF-808F-4CF6-8FC9-21B079F571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641833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B813F-7536-4757-AA28-A5B88A002BFA}" type="datetimeFigureOut">
              <a:rPr lang="de-DE" smtClean="0"/>
              <a:t>01.06.2019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E8AFF-808F-4CF6-8FC9-21B079F571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95583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B813F-7536-4757-AA28-A5B88A002BFA}" type="datetimeFigureOut">
              <a:rPr lang="de-DE" smtClean="0"/>
              <a:t>01.06.2019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E8AFF-808F-4CF6-8FC9-21B079F571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707707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B813F-7536-4757-AA28-A5B88A002BFA}" type="datetimeFigureOut">
              <a:rPr lang="de-DE" smtClean="0"/>
              <a:t>01.06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E8AFF-808F-4CF6-8FC9-21B079F571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09117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B813F-7536-4757-AA28-A5B88A002BFA}" type="datetimeFigureOut">
              <a:rPr lang="de-DE" smtClean="0"/>
              <a:t>01.06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E8AFF-808F-4CF6-8FC9-21B079F571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54122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7B813F-7536-4757-AA28-A5B88A002BFA}" type="datetimeFigureOut">
              <a:rPr lang="de-DE" smtClean="0"/>
              <a:t>01.06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BE8AFF-808F-4CF6-8FC9-21B079F571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0960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2.xml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Diagramm 10">
            <a:extLst>
              <a:ext uri="{FF2B5EF4-FFF2-40B4-BE49-F238E27FC236}">
                <a16:creationId xmlns="" xmlns:a16="http://schemas.microsoft.com/office/drawing/2014/main" id="{4D3C499E-71A3-4E86-881B-6C6EFB1B2132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866562583"/>
              </p:ext>
            </p:extLst>
          </p:nvPr>
        </p:nvGraphicFramePr>
        <p:xfrm>
          <a:off x="1152670" y="7198303"/>
          <a:ext cx="3552825" cy="20210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4" name="Grafik 3">
            <a:extLst>
              <a:ext uri="{FF2B5EF4-FFF2-40B4-BE49-F238E27FC236}">
                <a16:creationId xmlns="" xmlns:a16="http://schemas.microsoft.com/office/drawing/2014/main" id="{200DC7A7-6D8D-4E8A-88C5-9E7E2ACD0D9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5854"/>
          <a:stretch/>
        </p:blipFill>
        <p:spPr>
          <a:xfrm>
            <a:off x="1111098" y="5629205"/>
            <a:ext cx="4870995" cy="215318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5" name="Textfeld 4">
            <a:extLst>
              <a:ext uri="{FF2B5EF4-FFF2-40B4-BE49-F238E27FC236}">
                <a16:creationId xmlns="" xmlns:a16="http://schemas.microsoft.com/office/drawing/2014/main" id="{29DAC4FA-86E4-453D-94CF-63D2D5A50DE4}"/>
              </a:ext>
            </a:extLst>
          </p:cNvPr>
          <p:cNvSpPr txBox="1"/>
          <p:nvPr/>
        </p:nvSpPr>
        <p:spPr>
          <a:xfrm>
            <a:off x="1120623" y="5570369"/>
            <a:ext cx="49183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Chr.1        Chr. 2      Chr. 3      Chr. 4      Chr. 5       Chr. 6       Chr. 7      Chr. 8      Chr. 9      Chr. 10    Chr. 11     Chr.12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="" xmlns:a16="http://schemas.microsoft.com/office/drawing/2014/main" id="{9062FA42-D65E-41A8-8BD8-B71290ED7B10}"/>
              </a:ext>
            </a:extLst>
          </p:cNvPr>
          <p:cNvSpPr txBox="1"/>
          <p:nvPr/>
        </p:nvSpPr>
        <p:spPr>
          <a:xfrm>
            <a:off x="1130148" y="6852322"/>
            <a:ext cx="490070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Chr.13    Chr. 14    Chr. 15    Chr. 16     Chr. 17    Chr. 18     Chr. 19     Chr. 20    Chr. 21    Chr. 22     Chr. X      Chr. Y</a:t>
            </a:r>
          </a:p>
        </p:txBody>
      </p:sp>
      <p:pic>
        <p:nvPicPr>
          <p:cNvPr id="8" name="Grafik 7">
            <a:extLst>
              <a:ext uri="{FF2B5EF4-FFF2-40B4-BE49-F238E27FC236}">
                <a16:creationId xmlns="" xmlns:a16="http://schemas.microsoft.com/office/drawing/2014/main" id="{8704D2C6-C019-4CA2-944C-1001921B7C0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5709"/>
          <a:stretch/>
        </p:blipFill>
        <p:spPr>
          <a:xfrm>
            <a:off x="1148672" y="484884"/>
            <a:ext cx="4861395" cy="215265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9" name="Textfeld 8">
            <a:extLst>
              <a:ext uri="{FF2B5EF4-FFF2-40B4-BE49-F238E27FC236}">
                <a16:creationId xmlns="" xmlns:a16="http://schemas.microsoft.com/office/drawing/2014/main" id="{0C387242-1AD0-4CEC-94D7-E5A783E0A08D}"/>
              </a:ext>
            </a:extLst>
          </p:cNvPr>
          <p:cNvSpPr txBox="1"/>
          <p:nvPr/>
        </p:nvSpPr>
        <p:spPr>
          <a:xfrm>
            <a:off x="1148672" y="429443"/>
            <a:ext cx="49183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Chr.1        Chr. 2      Chr. 3      Chr. 4      Chr. 5       Chr. 6       Chr. 7      Chr. 8      Chr. 9      Chr. 10    Chr. 11     Chr.12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="" xmlns:a16="http://schemas.microsoft.com/office/drawing/2014/main" id="{9FD553B1-4EF1-48FD-95D0-E46CD351453F}"/>
              </a:ext>
            </a:extLst>
          </p:cNvPr>
          <p:cNvSpPr txBox="1"/>
          <p:nvPr/>
        </p:nvSpPr>
        <p:spPr>
          <a:xfrm>
            <a:off x="1158197" y="1711396"/>
            <a:ext cx="490070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Chr.13    Chr. 14    Chr. 15    Chr. 16     Chr. 17    Chr. 18     Chr. 19     Chr. 20    Chr. 21    Chr. 22     Chr. X      Chr. Y</a:t>
            </a:r>
          </a:p>
        </p:txBody>
      </p:sp>
      <p:graphicFrame>
        <p:nvGraphicFramePr>
          <p:cNvPr id="12" name="Diagramm 11">
            <a:extLst>
              <a:ext uri="{FF2B5EF4-FFF2-40B4-BE49-F238E27FC236}">
                <a16:creationId xmlns="" xmlns:a16="http://schemas.microsoft.com/office/drawing/2014/main" id="{3CB22931-7C6F-4B4F-A92D-3130BD03D36A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343012938"/>
              </p:ext>
            </p:extLst>
          </p:nvPr>
        </p:nvGraphicFramePr>
        <p:xfrm>
          <a:off x="1139147" y="2637535"/>
          <a:ext cx="3552825" cy="20210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" name="Textfeld 1"/>
          <p:cNvSpPr txBox="1"/>
          <p:nvPr/>
        </p:nvSpPr>
        <p:spPr>
          <a:xfrm>
            <a:off x="768928" y="37597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  <p:sp>
        <p:nvSpPr>
          <p:cNvPr id="13" name="Textfeld 12"/>
          <p:cNvSpPr txBox="1"/>
          <p:nvPr/>
        </p:nvSpPr>
        <p:spPr>
          <a:xfrm>
            <a:off x="744683" y="550263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  <p:sp>
        <p:nvSpPr>
          <p:cNvPr id="3" name="Textfeld 2"/>
          <p:cNvSpPr txBox="1"/>
          <p:nvPr/>
        </p:nvSpPr>
        <p:spPr>
          <a:xfrm>
            <a:off x="5167511" y="9402864"/>
            <a:ext cx="15714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uppl</a:t>
            </a:r>
            <a:r>
              <a:rPr lang="de-DE" dirty="0" smtClean="0"/>
              <a:t>. </a:t>
            </a:r>
            <a:r>
              <a:rPr lang="de-DE" dirty="0" err="1" smtClean="0"/>
              <a:t>Figure</a:t>
            </a:r>
            <a:r>
              <a:rPr lang="de-DE" smtClean="0"/>
              <a:t> </a:t>
            </a:r>
            <a:r>
              <a:rPr lang="de-DE" smtClean="0"/>
              <a:t>1</a:t>
            </a:r>
            <a:endParaRPr lang="de-DE" dirty="0"/>
          </a:p>
        </p:txBody>
      </p:sp>
      <p:sp>
        <p:nvSpPr>
          <p:cNvPr id="7" name="Textfeld 6"/>
          <p:cNvSpPr txBox="1"/>
          <p:nvPr/>
        </p:nvSpPr>
        <p:spPr>
          <a:xfrm>
            <a:off x="2290951" y="4591575"/>
            <a:ext cx="11256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ge at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agnosis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2290951" y="9217407"/>
            <a:ext cx="11256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ge at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agnosis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7021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44</Words>
  <Application>Microsoft Office PowerPoint</Application>
  <PresentationFormat>A4-Papier (210x297 mm)</PresentationFormat>
  <Paragraphs>9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tephanie</dc:creator>
  <cp:lastModifiedBy>DrTorstenPietsch</cp:lastModifiedBy>
  <cp:revision>17</cp:revision>
  <dcterms:created xsi:type="dcterms:W3CDTF">2017-09-29T08:04:12Z</dcterms:created>
  <dcterms:modified xsi:type="dcterms:W3CDTF">2019-05-31T22:11:48Z</dcterms:modified>
</cp:coreProperties>
</file>